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7" r:id="rId3"/>
  </p:sldIdLst>
  <p:sldSz cx="12192000" cy="6858000"/>
  <p:notesSz cx="7103745" cy="10234295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无样式，网格型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33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6" Type="http://schemas.openxmlformats.org/officeDocument/2006/relationships/tableStyles" Target="tableStyles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内容占位符 1"/>
          <p:cNvSpPr>
            <a:spLocks noGrp="1"/>
          </p:cNvSpPr>
          <p:nvPr>
            <p:ph/>
          </p:nvPr>
        </p:nvSpPr>
        <p:spPr>
          <a:xfrm>
            <a:off x="838200" y="365125"/>
            <a:ext cx="10515600" cy="58118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1186774" y="1778438"/>
            <a:ext cx="4873574" cy="823912"/>
          </a:xfrm>
        </p:spPr>
        <p:txBody>
          <a:bodyPr anchor="ctr" anchorCtr="0"/>
          <a:lstStyle>
            <a:lvl1pPr marL="0" indent="0">
              <a:buNone/>
              <a:defRPr sz="2800"/>
            </a:lvl1pPr>
            <a:lvl2pPr marL="457200" indent="0">
              <a:buNone/>
              <a:defRPr sz="2400"/>
            </a:lvl2pPr>
            <a:lvl3pPr marL="914400" indent="0">
              <a:buNone/>
              <a:defRPr sz="2000"/>
            </a:lvl3pPr>
            <a:lvl4pPr marL="1371600" indent="0">
              <a:buNone/>
              <a:defRPr sz="1800"/>
            </a:lvl4pPr>
            <a:lvl5pPr marL="1828800" indent="0">
              <a:buNone/>
              <a:defRPr sz="1800"/>
            </a:lvl5pPr>
            <a:lvl6pPr marL="2286000" indent="0">
              <a:buNone/>
              <a:defRPr sz="1800"/>
            </a:lvl6pPr>
            <a:lvl7pPr marL="2743200" indent="0">
              <a:buNone/>
              <a:defRPr sz="1800"/>
            </a:lvl7pPr>
            <a:lvl8pPr marL="3200400" indent="0">
              <a:buNone/>
              <a:defRPr sz="1800"/>
            </a:lvl8pPr>
            <a:lvl9pPr marL="3657600" indent="0">
              <a:buNone/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1186774" y="2665379"/>
            <a:ext cx="4873574" cy="3524284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256938" y="1778438"/>
            <a:ext cx="4897576" cy="823912"/>
          </a:xfrm>
        </p:spPr>
        <p:txBody>
          <a:bodyPr anchor="ctr" anchorCtr="0"/>
          <a:lstStyle>
            <a:lvl1pPr marL="0" indent="0">
              <a:buNone/>
              <a:defRPr sz="2800"/>
            </a:lvl1pPr>
            <a:lvl2pPr marL="457200" indent="0">
              <a:buNone/>
              <a:defRPr sz="2400"/>
            </a:lvl2pPr>
            <a:lvl3pPr marL="914400" indent="0">
              <a:buNone/>
              <a:defRPr sz="2000"/>
            </a:lvl3pPr>
            <a:lvl4pPr marL="1371600" indent="0">
              <a:buNone/>
              <a:defRPr sz="1800"/>
            </a:lvl4pPr>
            <a:lvl5pPr marL="1828800" indent="0">
              <a:buNone/>
              <a:defRPr sz="1800"/>
            </a:lvl5pPr>
            <a:lvl6pPr marL="2286000" indent="0">
              <a:buNone/>
              <a:defRPr sz="1800"/>
            </a:lvl6pPr>
            <a:lvl7pPr marL="2743200" indent="0">
              <a:buNone/>
              <a:defRPr sz="1800"/>
            </a:lvl7pPr>
            <a:lvl8pPr marL="3200400" indent="0">
              <a:buNone/>
              <a:defRPr sz="1800"/>
            </a:lvl8pPr>
            <a:lvl9pPr marL="3657600" indent="0">
              <a:buNone/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256938" y="2665379"/>
            <a:ext cx="4897576" cy="3524284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4165349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457201"/>
            <a:ext cx="6172200" cy="540385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4165349" cy="3811588"/>
          </a:xfrm>
        </p:spPr>
        <p:txBody>
          <a:bodyPr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1" Type="http://schemas.openxmlformats.org/officeDocument/2006/relationships/theme" Target="../theme/theme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F288E0-7875-42C4-84C8-98DBBD3BF4D2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9BB5D0-35E4-459D-AEF3-FE4D7C45CC19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9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9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2170523" y="205573"/>
            <a:ext cx="7536729" cy="27559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200" b="1" dirty="0">
                <a:solidFill>
                  <a:srgbClr val="000000"/>
                </a:solidFill>
                <a:latin typeface="Times New Roman" panose="02020503050405090304" pitchFamily="18" charset="0"/>
                <a:sym typeface="+mn-ea"/>
              </a:rPr>
              <a:t>Additional file 2</a:t>
            </a:r>
            <a:r>
              <a:rPr lang="en-US" sz="1200" dirty="0">
                <a:solidFill>
                  <a:srgbClr val="000000"/>
                </a:solidFill>
                <a:latin typeface="Times New Roman" panose="02020503050405090304" pitchFamily="18" charset="0"/>
              </a:rPr>
              <a:t>. Included number, CT value, SUV</a:t>
            </a:r>
            <a:r>
              <a:rPr lang="en-US" sz="1200" baseline="-25000" dirty="0">
                <a:solidFill>
                  <a:srgbClr val="000000"/>
                </a:solidFill>
                <a:latin typeface="Times New Roman" panose="02020503050405090304" pitchFamily="18" charset="0"/>
              </a:rPr>
              <a:t>max </a:t>
            </a:r>
            <a:r>
              <a:rPr lang="en-US" sz="1200" dirty="0">
                <a:solidFill>
                  <a:srgbClr val="000000"/>
                </a:solidFill>
                <a:latin typeface="Times New Roman" panose="02020503050405090304" pitchFamily="18" charset="0"/>
              </a:rPr>
              <a:t>and </a:t>
            </a:r>
            <a:r>
              <a:rPr lang="en-US" sz="1200" dirty="0" err="1">
                <a:solidFill>
                  <a:srgbClr val="000000"/>
                </a:solidFill>
                <a:latin typeface="Times New Roman" panose="02020503050405090304" pitchFamily="18" charset="0"/>
              </a:rPr>
              <a:t>SUV</a:t>
            </a:r>
            <a:r>
              <a:rPr lang="en-US" sz="1200" baseline="-25000" dirty="0" err="1">
                <a:solidFill>
                  <a:srgbClr val="000000"/>
                </a:solidFill>
                <a:latin typeface="Times New Roman" panose="02020503050405090304" pitchFamily="18" charset="0"/>
              </a:rPr>
              <a:t>mean</a:t>
            </a:r>
            <a:r>
              <a:rPr lang="en-US" sz="1200" baseline="-25000" dirty="0">
                <a:solidFill>
                  <a:srgbClr val="000000"/>
                </a:solidFill>
                <a:latin typeface="Times New Roman" panose="02020503050405090304" pitchFamily="18" charset="0"/>
              </a:rPr>
              <a:t> </a:t>
            </a:r>
            <a:r>
              <a:rPr lang="en-US" sz="1200" dirty="0">
                <a:solidFill>
                  <a:srgbClr val="000000"/>
                </a:solidFill>
                <a:latin typeface="Times New Roman" panose="02020503050405090304" pitchFamily="18" charset="0"/>
              </a:rPr>
              <a:t>of normal vertebrae in female participants</a:t>
            </a:r>
            <a:r>
              <a:rPr lang="en-US" sz="1200" dirty="0">
                <a:effectLst/>
              </a:rPr>
              <a:t> </a:t>
            </a:r>
            <a:endParaRPr lang="en-US" sz="1200" dirty="0"/>
          </a:p>
        </p:txBody>
      </p:sp>
      <p:graphicFrame>
        <p:nvGraphicFramePr>
          <p:cNvPr id="3" name="Table 2"/>
          <p:cNvGraphicFramePr>
            <a:graphicFrameLocks noGrp="1"/>
          </p:cNvGraphicFramePr>
          <p:nvPr/>
        </p:nvGraphicFramePr>
        <p:xfrm>
          <a:off x="1461155" y="528258"/>
          <a:ext cx="8955467" cy="5985669"/>
        </p:xfrm>
        <a:graphic>
          <a:graphicData uri="http://schemas.openxmlformats.org/drawingml/2006/table">
            <a:tbl>
              <a:tblPr>
                <a:tableStyleId>{5940675A-B579-460E-94D1-54222C63F5DA}</a:tableStyleId>
              </a:tblPr>
              <a:tblGrid>
                <a:gridCol w="619572"/>
                <a:gridCol w="643812"/>
                <a:gridCol w="1830384"/>
                <a:gridCol w="967432"/>
                <a:gridCol w="1013079"/>
                <a:gridCol w="829345"/>
                <a:gridCol w="1036682"/>
                <a:gridCol w="1102155"/>
                <a:gridCol w="913006"/>
              </a:tblGrid>
              <a:tr h="224790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Vertebrae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Included number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CT values (HU）mean±SD，CoV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SUV</a:t>
                      </a:r>
                      <a:r>
                        <a:rPr lang="en-US" sz="1000" u="none" strike="noStrike" baseline="-25000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max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 hMerge="1">
                  <a:tcPr/>
                </a:tc>
                <a:tc hMerge="1">
                  <a:tcPr/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SUV</a:t>
                      </a:r>
                      <a:r>
                        <a:rPr lang="en-US" sz="1000" u="none" strike="noStrike" baseline="-25000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mean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 hMerge="1">
                  <a:tcPr/>
                </a:tc>
                <a:tc hMerge="1">
                  <a:tcPr/>
                </a:tc>
              </a:tr>
              <a:tr h="235244">
                <a:tc vMerge="1">
                  <a:tcPr/>
                </a:tc>
                <a:tc vMerge="1">
                  <a:tcPr/>
                </a:tc>
                <a:tc vMerge="1"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(mean±SD)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Range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CoV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(mean±SD)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Range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CoV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</a:tr>
              <a:tr h="23001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C1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3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407±90，0.2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6.32±1.7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2.72-9.8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2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3.80±0.6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2.65-4.9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1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</a:tr>
              <a:tr h="23001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C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4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351±105，0.3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6.32±1.5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2.47-10.0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2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3.96±0.6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2.47-5.2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1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</a:tr>
              <a:tr h="23001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C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5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323±77，0.2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6.65±1.5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2.97-10.2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2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4.33±0.9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2.69-7.3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2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</a:tr>
              <a:tr h="23001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C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5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348±83，0.2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7.09±1.8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3.14-10.8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2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4.66±1.2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2.74-8.6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2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</a:tr>
              <a:tr h="23001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C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5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337±72，0.2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7.11±1.5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3.60-10.2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2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4.71±1.1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2.93-8.9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2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</a:tr>
              <a:tr h="23001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C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5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301±64，0.2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7.03±1.5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3.87-10.5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2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4.76±1.0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2.96-8.7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2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</a:tr>
              <a:tr h="23001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C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6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272±57，0.2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7.17±1.6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3.64-10.4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2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4.85±1.0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2.89-6.6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2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</a:tr>
              <a:tr h="23001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T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6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245±57，0.2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7.29±1.5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3.74-10.5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2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4.92±1.0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2.92-7.1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2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</a:tr>
              <a:tr h="23001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T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6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230±43，0.1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6.99±1.5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3.07-9.9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2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4.64±0.9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2.95-7.1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</a:tr>
              <a:tr h="23001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T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4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221±44，0.2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6.91±1.8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2.50-11.6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2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4.43±0.9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2.50-6.4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2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</a:tr>
              <a:tr h="23001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T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4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215±44，0.2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6.77±1.6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3.20-10.1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2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4.46±1.1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2.83-8.3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2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</a:tr>
              <a:tr h="23001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T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4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205±44，0.2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6.77±1.7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3.66-11.4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2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4.51±1.0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2.92-7.9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2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</a:tr>
              <a:tr h="23001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T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4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195±39，0.2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7.03±1.8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2.64-10.7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2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4.55±1.0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2.55-7.2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2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</a:tr>
              <a:tr h="23001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T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5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186±42，0.2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6.96±1.7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3.09-10.1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2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4.60±1.0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2.80-7.4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2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</a:tr>
              <a:tr h="23001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T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5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182±42，0.2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7.06±1.6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3.44-9.8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2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4.59±1.0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3.01-7.1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2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</a:tr>
              <a:tr h="23001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T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5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178±47，0.2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7.24±1.6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3.83-10.4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2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4.72±0.9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3.14-6.5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2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</a:tr>
              <a:tr h="23001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T1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5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179±44，0.2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6.98±1.7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3.40-11.4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2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4.61±0.9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2.93-6.3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</a:tr>
              <a:tr h="23001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T1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5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170±44，0.2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7.06±1.8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2.93-11.0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2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4.58±0.9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2.65-6.2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</a:tr>
              <a:tr h="23001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T1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5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155±41，0.2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6.98±1.7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2.77-12.5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2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4.70±1.0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2.77-8.9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2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</a:tr>
              <a:tr h="23001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L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5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144±37，0.2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7.18±1.6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3.19-10.5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2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4.87±1.0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3.17-7.0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2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</a:tr>
              <a:tr h="23001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L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4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146±40，0.2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6.81±1.1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4.15-9.5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1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4.70±0.8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3.28-6.7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1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</a:tr>
              <a:tr h="23001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L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4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142±49，0.3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6.70±1.3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3.18-9.3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4.43±0.7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2.75-6.2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1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</a:tr>
              <a:tr h="23001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L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5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155±49，0.3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7.21±1.7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3.37-11.2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2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4.54±1.1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2.55-9.9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2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</a:tr>
              <a:tr h="23524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L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4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158±59，0.3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7.18±1.7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4.65-10.5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2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4.85±1.4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3.33-11.0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  <a:latin typeface="Times New Roman" panose="02020503050405090304" pitchFamily="18" charset="0"/>
                          <a:cs typeface="Times New Roman" panose="02020503050405090304" pitchFamily="18" charset="0"/>
                        </a:rPr>
                        <a:t>0.29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503050405090304" pitchFamily="18" charset="0"/>
                        <a:cs typeface="Times New Roman" panose="02020503050405090304" pitchFamily="18" charset="0"/>
                      </a:endParaRPr>
                    </a:p>
                  </a:txBody>
                  <a:tcPr marL="3800" marR="3800" marT="3800" marB="0" anchor="ctr"/>
                </a:tc>
              </a:tr>
            </a:tbl>
          </a:graphicData>
        </a:graphic>
      </p:graphicFrame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715</Words>
  <Application>WPS 文字</Application>
  <PresentationFormat>宽屏</PresentationFormat>
  <Paragraphs>470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12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14" baseType="lpstr">
      <vt:lpstr>Arial</vt:lpstr>
      <vt:lpstr>方正书宋_GBK</vt:lpstr>
      <vt:lpstr>Wingdings</vt:lpstr>
      <vt:lpstr>宋体</vt:lpstr>
      <vt:lpstr>Arial Unicode MS</vt:lpstr>
      <vt:lpstr>汉仪书宋二KW</vt:lpstr>
      <vt:lpstr>Calibri Light</vt:lpstr>
      <vt:lpstr>Helvetica Neue</vt:lpstr>
      <vt:lpstr>Calibri</vt:lpstr>
      <vt:lpstr>微软雅黑</vt:lpstr>
      <vt:lpstr>汉仪旗黑KW</vt:lpstr>
      <vt:lpstr>Times New Roman</vt:lpstr>
      <vt:lpstr>Office 主题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qina</dc:creator>
  <cp:lastModifiedBy>qina</cp:lastModifiedBy>
  <cp:revision>1</cp:revision>
  <dcterms:created xsi:type="dcterms:W3CDTF">2020-12-16T11:29:41Z</dcterms:created>
  <dcterms:modified xsi:type="dcterms:W3CDTF">2020-12-16T11:29:4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.5.2.2273</vt:lpwstr>
  </property>
</Properties>
</file>